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87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-36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31680" y="741240"/>
            <a:ext cx="4933800" cy="3702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690800"/>
            <a:ext cx="5438880" cy="444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37872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378720"/>
            <a:ext cx="2946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B0FD52-33FD-4CC4-A71A-9DB64AC50A55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sldImg"/>
          </p:nvPr>
        </p:nvSpPr>
        <p:spPr>
          <a:xfrm>
            <a:off x="932040" y="741240"/>
            <a:ext cx="4933800" cy="3702240"/>
          </a:xfrm>
          <a:prstGeom prst="rect">
            <a:avLst/>
          </a:prstGeom>
          <a:ln w="0">
            <a:noFill/>
          </a:ln>
        </p:spPr>
      </p:sp>
      <p:sp>
        <p:nvSpPr>
          <p:cNvPr id="61" name="PlaceHolder 2"/>
          <p:cNvSpPr>
            <a:spLocks noGrp="1"/>
          </p:cNvSpPr>
          <p:nvPr>
            <p:ph type="body"/>
          </p:nvPr>
        </p:nvSpPr>
        <p:spPr>
          <a:xfrm>
            <a:off x="679320" y="4690800"/>
            <a:ext cx="5438880" cy="44434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[AT1G29490  -  saur-like auxin-responsive protein, AT2G21220  -  saur-like auxin-responsive protein, AT1G29440  -  saur-like auxin-responsive protein, AT3G03820  -  saur-like auxin-responsive protein, AT1G29430  -  saur-like auxin-responsive protein, AT5G18050  -  saur-like auxin-responsive protein, AT4G34790  -  saur-like auxin-responsive protein, AT5G27780  -  saur-like auxin-responsive protein, AT5G18060  -  saur-like auxin-responsive protein, AT5G18080  -  saur-like auxin-responsive protein]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</a:rPr>
              <a:t>Enrichment = (b/n) / (B/N) = 25.8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 = total number of genes in microarray associated with a GO term (1622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 = total number of genes in microarray associated with a specific GO term (116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 = number of down-regulated genes i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rug1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microarray associated with a GO term (64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 = number of down-regulated genes in rug1 microarray associated with a specific GO term (10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3 Marcador de número de diapositiva"/>
          <p:cNvSpPr/>
          <p:nvPr/>
        </p:nvSpPr>
        <p:spPr>
          <a:xfrm>
            <a:off x="3849840" y="9379080"/>
            <a:ext cx="2946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AB6B29-CFE8-4160-A643-9F45AC66D8AD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sldImg"/>
          </p:nvPr>
        </p:nvSpPr>
        <p:spPr>
          <a:xfrm>
            <a:off x="932040" y="741240"/>
            <a:ext cx="4933800" cy="3702240"/>
          </a:xfrm>
          <a:prstGeom prst="rect">
            <a:avLst/>
          </a:prstGeom>
          <a:ln w="0">
            <a:noFill/>
          </a:ln>
        </p:spPr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679320" y="4690800"/>
            <a:ext cx="5438880" cy="44434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</a:rPr>
              <a:t>Enrichment = (b/n) / (B/N) = 25.8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 = total number of genes in microarray associated with a GO term (1622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 = total number of genes in microarray associated with a specific GO term (116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 = number of down-regulated genes i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rug1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microarray associated with a GO term (64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 = number of down-regulated genes in rug1 microarray associated with a specific GO term (10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3 Marcador de número de diapositiva"/>
          <p:cNvSpPr/>
          <p:nvPr/>
        </p:nvSpPr>
        <p:spPr>
          <a:xfrm>
            <a:off x="3849840" y="9379080"/>
            <a:ext cx="2946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E05631-248C-4EC7-8EA7-25E2E5449B00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9831EF-94FB-4B4C-A47B-DAE670D8A47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D97D5-4A4A-4184-9001-7ED19785C8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ADDC80-F6E2-4EC3-AF73-C942BB6CC3B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1B566-A9AF-49B2-BBE0-915B233104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5EA6A7-78AE-4F89-9F98-501E625E2F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3EBCD-96CE-4E91-B9C8-54E678BD03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AE20A-F717-4DF5-A313-F166328B50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AAC8D0-2C33-4A22-8197-678BE3856B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1B33D4-55C0-4C31-9EA5-C19F14648C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33541-6AF9-4DD4-A53E-2C6249574B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FE9A8-F947-4E14-9C72-9E63D215E1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6237C2-C7A6-443E-A595-00E931EBC0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29C255-5DD1-4897-9675-A912D26E2F6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2916360" y="836640"/>
            <a:ext cx="3095640" cy="4968720"/>
            <a:chOff x="2916360" y="836640"/>
            <a:chExt cx="3095640" cy="4968720"/>
          </a:xfrm>
        </p:grpSpPr>
        <p:pic>
          <p:nvPicPr>
            <p:cNvPr id="49" name="1 Imagen" descr=""/>
            <p:cNvPicPr/>
            <p:nvPr/>
          </p:nvPicPr>
          <p:blipFill>
            <a:blip r:embed="rId1"/>
            <a:stretch/>
          </p:blipFill>
          <p:spPr>
            <a:xfrm>
              <a:off x="2916360" y="836640"/>
              <a:ext cx="3076560" cy="496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5 CuadroTexto"/>
            <p:cNvSpPr/>
            <p:nvPr/>
          </p:nvSpPr>
          <p:spPr>
            <a:xfrm>
              <a:off x="4211640" y="5300640"/>
              <a:ext cx="18003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Calibri"/>
                </a:rPr>
                <a:t>FDR q-value = 6.04E-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Calibri"/>
                </a:rPr>
                <a:t>Gene enrichment = 25.8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aphicFrame>
        <p:nvGraphicFramePr>
          <p:cNvPr id="51" name=""/>
          <p:cNvGraphicFramePr/>
          <p:nvPr/>
        </p:nvGraphicFramePr>
        <p:xfrm>
          <a:off x="1370160" y="6453360"/>
          <a:ext cx="3889080" cy="274320"/>
        </p:xfrm>
        <a:graphic>
          <a:graphicData uri="http://schemas.openxmlformats.org/drawingml/2006/table">
            <a:tbl>
              <a:tblPr/>
              <a:tblGrid>
                <a:gridCol w="720720"/>
                <a:gridCol w="863280"/>
                <a:gridCol w="865440"/>
                <a:gridCol w="863640"/>
                <a:gridCol w="576000"/>
              </a:tblGrid>
              <a:tr h="2764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gt; 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r>
                        <a:rPr b="0" lang="es-E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3</a:t>
                      </a: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to 10</a:t>
                      </a:r>
                      <a:r>
                        <a:rPr b="0" lang="es-E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r>
                        <a:rPr b="0" lang="es-E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5</a:t>
                      </a: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to 10</a:t>
                      </a:r>
                      <a:r>
                        <a:rPr b="0" lang="es-E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66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r>
                        <a:rPr b="0" lang="es-E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7</a:t>
                      </a: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to 10</a:t>
                      </a:r>
                      <a:r>
                        <a:rPr b="0" lang="es-E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900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 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300"/>
                    </a:solidFill>
                  </a:tcPr>
                </a:tc>
              </a:tr>
            </a:tbl>
          </a:graphicData>
        </a:graphic>
      </p:graphicFrame>
      <p:sp>
        <p:nvSpPr>
          <p:cNvPr id="52" name="Rectangle 1"/>
          <p:cNvSpPr/>
          <p:nvPr/>
        </p:nvSpPr>
        <p:spPr>
          <a:xfrm>
            <a:off x="36000" y="6450480"/>
            <a:ext cx="133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P-value color sca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"/>
          <p:cNvSpPr/>
          <p:nvPr/>
        </p:nvSpPr>
        <p:spPr>
          <a:xfrm>
            <a:off x="3654360" y="26028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"/>
          <p:cNvSpPr/>
          <p:nvPr/>
        </p:nvSpPr>
        <p:spPr>
          <a:xfrm>
            <a:off x="2808000" y="54936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1 Imagen" descr=""/>
          <p:cNvPicPr/>
          <p:nvPr/>
        </p:nvPicPr>
        <p:blipFill>
          <a:blip r:embed="rId1"/>
          <a:stretch/>
        </p:blipFill>
        <p:spPr>
          <a:xfrm>
            <a:off x="6480" y="1341360"/>
            <a:ext cx="9144000" cy="37353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6" name=""/>
          <p:cNvGraphicFramePr/>
          <p:nvPr/>
        </p:nvGraphicFramePr>
        <p:xfrm>
          <a:off x="1370160" y="6453360"/>
          <a:ext cx="3889080" cy="274320"/>
        </p:xfrm>
        <a:graphic>
          <a:graphicData uri="http://schemas.openxmlformats.org/drawingml/2006/table">
            <a:tbl>
              <a:tblPr/>
              <a:tblGrid>
                <a:gridCol w="720720"/>
                <a:gridCol w="863280"/>
                <a:gridCol w="865440"/>
                <a:gridCol w="863640"/>
                <a:gridCol w="576000"/>
              </a:tblGrid>
              <a:tr h="2764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gt; 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r>
                        <a:rPr b="0" lang="es-E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3</a:t>
                      </a: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to 10</a:t>
                      </a:r>
                      <a:r>
                        <a:rPr b="0" lang="es-E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r>
                        <a:rPr b="0" lang="es-E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5</a:t>
                      </a: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to 10</a:t>
                      </a:r>
                      <a:r>
                        <a:rPr b="0" lang="es-E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66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r>
                        <a:rPr b="0" lang="es-E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7</a:t>
                      </a: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to 10</a:t>
                      </a:r>
                      <a:r>
                        <a:rPr b="0" lang="es-E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900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 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300"/>
                    </a:solidFill>
                  </a:tcPr>
                </a:tc>
              </a:tr>
            </a:tbl>
          </a:graphicData>
        </a:graphic>
      </p:graphicFrame>
      <p:sp>
        <p:nvSpPr>
          <p:cNvPr id="57" name="Rectangle 1"/>
          <p:cNvSpPr/>
          <p:nvPr/>
        </p:nvSpPr>
        <p:spPr>
          <a:xfrm>
            <a:off x="36000" y="6450480"/>
            <a:ext cx="133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  <a:ea typeface="Arial"/>
              </a:rPr>
              <a:t>P-value color sca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"/>
          <p:cNvSpPr/>
          <p:nvPr/>
        </p:nvSpPr>
        <p:spPr>
          <a:xfrm>
            <a:off x="3654360" y="26028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gure S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"/>
          <p:cNvSpPr/>
          <p:nvPr/>
        </p:nvSpPr>
        <p:spPr>
          <a:xfrm>
            <a:off x="1440" y="54936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16T07:42:55Z</dcterms:created>
  <dc:creator>mrponce</dc:creator>
  <dc:description/>
  <dc:language>en-US</dc:language>
  <cp:lastModifiedBy>vquesada</cp:lastModifiedBy>
  <cp:lastPrinted>2012-10-16T08:08:05Z</cp:lastPrinted>
  <dcterms:modified xsi:type="dcterms:W3CDTF">2012-11-12T12:04:58Z</dcterms:modified>
  <cp:revision>14</cp:revision>
  <dc:subject/>
  <dc:title>Presentación de PowerPoint</dc:title>
</cp:coreProperties>
</file>